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9" autoAdjust="0"/>
    <p:restoredTop sz="94660"/>
  </p:normalViewPr>
  <p:slideViewPr>
    <p:cSldViewPr snapToGrid="0" showGuides="1">
      <p:cViewPr varScale="1">
        <p:scale>
          <a:sx n="89" d="100"/>
          <a:sy n="89" d="100"/>
        </p:scale>
        <p:origin x="75" y="2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B61085-B898-4501-4DCD-75EE46F04E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53F64D5-4814-7404-07FD-DC5455B508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357D6F4-ED59-5FAC-0046-713B08E3B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DEE5B85-CAC3-02A6-2184-AD144A1AC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8C01E6-07AD-4BDF-345B-4D3A0B56B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728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0218F2-4828-DD0E-B4FD-93A07AD642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FFF5779-9D6D-ADC7-AF05-1A251FEA53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718103-677C-92CF-9CB7-5BD94DDAE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82B302-BD75-7B37-5190-34C1207B5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2C6131-729B-1D88-559B-B147843BA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0247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76F95F9-1722-6F23-49AB-0153B01630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5A82940-D5E8-F863-9E80-AB91BC3158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3DD53E-0932-7D74-4B15-1665A33B2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99186-D6EA-6636-AB25-47071BEEAD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714007-045C-6045-C45F-9F9601817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0621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1E0C85-6CE6-6468-5CD6-AF31E86EAC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A78967E-2B08-2C32-A84F-D7CA5DB37B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F67FA1A-C68C-DE07-73D6-66C65BD1E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1422324-37A9-1047-0090-5A5997DF4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A94866-5F60-7CA5-33D2-2453B2BCCA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7388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076A02-4AA6-51FC-83C5-E95070D85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BDDC221-03F3-7FB3-1A82-6F5CD91F40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9CF488-1999-C244-4FE5-09F89EA67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92435E-41F0-A688-22FA-0B3A349DC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91E9A7-3BE2-D4E0-E1AA-071A4141A9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6356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C61CEA-EBD5-E9B6-FB2B-B74F2DD7AF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3B5A4F2-22C0-D2D5-C704-0E75DD05E1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646A283-D05F-FBFF-4F58-93EE100CFD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2FC51C6-B57F-EB4C-BA31-CD5A4EFF9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DB191F-C7C4-4A76-5062-841D17C6D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27B033E-8B43-A165-FCA5-FB2A3C08D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6949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3700D6-3229-0CB0-878A-C714FE94E4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86F5195-70ED-F74C-7AD8-2AB4CF2F35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BAF7CCD-9D5F-A45C-6002-520B7AC718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805EA0F-4E49-A92E-C642-7CEA5B6A28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37B35D3-466D-F948-1A38-394A351EB4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EEBBE7C-8F29-55EE-03D2-0D23BC61A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448959F-96FB-124D-1AC2-304847023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8B8F902-ECA1-9CB8-2A73-C69A3BA1E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1059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3267D0-3365-C199-06B0-C9B6E3F261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5975BE8-88B3-FBB6-92AD-588EE0C8B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08C812D-79EE-3ECC-F2C4-44177F15E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9A686F7-900A-3977-6AC4-8418FBC1C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506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7F3D1D2-62F7-F78C-A0CF-B35139A42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35A82F3-5A42-7277-09FF-3EC6CA7AA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702F3BF-77A0-0AF2-F4AC-E8C23FF8F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031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58F64F-99A8-BDF1-4717-C015691257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1EE511A-39AF-BBE7-1B83-7282045A0D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BE0EB02-1A97-4752-FCEF-98627D3182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2A8F472-E1DB-49FC-C45D-3D247E758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159E84B-2247-C6D2-2700-D743B0A82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0B7C262-13BF-0ECC-3A06-D811F7947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157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1AD6EC-FEA0-D3E6-E145-552DB45E4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1727250-7C26-B064-B6C0-90CD322DB7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8B07D83-6111-9746-763C-63DA67FDAB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E72424-CC0A-DE97-FCB1-D6A2BDC00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3F170B-6DAE-6007-ACB6-94C1BA769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6323870-E151-1BBF-9D1F-413013E4E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2383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7F2B71A-C006-A902-CD60-B3BAC08F2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3DD4AC-0301-3E90-C3EB-EF805A0982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52EDCD-F437-75B0-3A8F-A9D3C6166A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4E5A67-8988-485B-8E14-CFA91D35F51A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A26672-D548-00EE-01FF-23F05892D5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8512FB-F1D5-BF68-1BB6-FAB6AB115B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33BFBD-8A21-4123-81B6-FA4EEF242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4159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id="{E434FB2F-188B-9FB0-C88F-354108B1051C}"/>
              </a:ext>
            </a:extLst>
          </p:cNvPr>
          <p:cNvGrpSpPr/>
          <p:nvPr/>
        </p:nvGrpSpPr>
        <p:grpSpPr bwMode="auto">
          <a:xfrm>
            <a:off x="4392612" y="525462"/>
            <a:ext cx="3406775" cy="5807075"/>
            <a:chOff x="0" y="0"/>
            <a:chExt cx="2146" cy="3658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id="{44DE18C9-DB9B-CCCF-96DD-62E572F28028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2146" cy="36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" name="Freeform 5">
              <a:extLst>
                <a:ext uri="{FF2B5EF4-FFF2-40B4-BE49-F238E27FC236}">
                  <a16:creationId xmlns:a16="http://schemas.microsoft.com/office/drawing/2014/main" id="{98E82C84-3980-AD36-75E8-5C4462B0C9D3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" y="11"/>
              <a:ext cx="567" cy="226"/>
            </a:xfrm>
            <a:custGeom>
              <a:avLst/>
              <a:gdLst>
                <a:gd name="T0" fmla="*/ 115 w 567"/>
                <a:gd name="T1" fmla="*/ 226 h 226"/>
                <a:gd name="T2" fmla="*/ 455 w 567"/>
                <a:gd name="T3" fmla="*/ 226 h 226"/>
                <a:gd name="T4" fmla="*/ 477 w 567"/>
                <a:gd name="T5" fmla="*/ 224 h 226"/>
                <a:gd name="T6" fmla="*/ 498 w 567"/>
                <a:gd name="T7" fmla="*/ 218 h 226"/>
                <a:gd name="T8" fmla="*/ 518 w 567"/>
                <a:gd name="T9" fmla="*/ 207 h 226"/>
                <a:gd name="T10" fmla="*/ 535 w 567"/>
                <a:gd name="T11" fmla="*/ 194 h 226"/>
                <a:gd name="T12" fmla="*/ 548 w 567"/>
                <a:gd name="T13" fmla="*/ 177 h 226"/>
                <a:gd name="T14" fmla="*/ 559 w 567"/>
                <a:gd name="T15" fmla="*/ 157 h 226"/>
                <a:gd name="T16" fmla="*/ 565 w 567"/>
                <a:gd name="T17" fmla="*/ 136 h 226"/>
                <a:gd name="T18" fmla="*/ 567 w 567"/>
                <a:gd name="T19" fmla="*/ 112 h 226"/>
                <a:gd name="T20" fmla="*/ 565 w 567"/>
                <a:gd name="T21" fmla="*/ 90 h 226"/>
                <a:gd name="T22" fmla="*/ 559 w 567"/>
                <a:gd name="T23" fmla="*/ 69 h 226"/>
                <a:gd name="T24" fmla="*/ 548 w 567"/>
                <a:gd name="T25" fmla="*/ 49 h 226"/>
                <a:gd name="T26" fmla="*/ 535 w 567"/>
                <a:gd name="T27" fmla="*/ 32 h 226"/>
                <a:gd name="T28" fmla="*/ 518 w 567"/>
                <a:gd name="T29" fmla="*/ 19 h 226"/>
                <a:gd name="T30" fmla="*/ 498 w 567"/>
                <a:gd name="T31" fmla="*/ 8 h 226"/>
                <a:gd name="T32" fmla="*/ 477 w 567"/>
                <a:gd name="T33" fmla="*/ 2 h 226"/>
                <a:gd name="T34" fmla="*/ 455 w 567"/>
                <a:gd name="T35" fmla="*/ 0 h 226"/>
                <a:gd name="T36" fmla="*/ 455 w 567"/>
                <a:gd name="T37" fmla="*/ 0 h 226"/>
                <a:gd name="T38" fmla="*/ 455 w 567"/>
                <a:gd name="T39" fmla="*/ 0 h 226"/>
                <a:gd name="T40" fmla="*/ 115 w 567"/>
                <a:gd name="T41" fmla="*/ 0 h 226"/>
                <a:gd name="T42" fmla="*/ 91 w 567"/>
                <a:gd name="T43" fmla="*/ 2 h 226"/>
                <a:gd name="T44" fmla="*/ 69 w 567"/>
                <a:gd name="T45" fmla="*/ 8 h 226"/>
                <a:gd name="T46" fmla="*/ 52 w 567"/>
                <a:gd name="T47" fmla="*/ 19 h 226"/>
                <a:gd name="T48" fmla="*/ 35 w 567"/>
                <a:gd name="T49" fmla="*/ 32 h 226"/>
                <a:gd name="T50" fmla="*/ 20 w 567"/>
                <a:gd name="T51" fmla="*/ 49 h 226"/>
                <a:gd name="T52" fmla="*/ 9 w 567"/>
                <a:gd name="T53" fmla="*/ 69 h 226"/>
                <a:gd name="T54" fmla="*/ 3 w 567"/>
                <a:gd name="T55" fmla="*/ 90 h 226"/>
                <a:gd name="T56" fmla="*/ 0 w 567"/>
                <a:gd name="T57" fmla="*/ 112 h 226"/>
                <a:gd name="T58" fmla="*/ 3 w 567"/>
                <a:gd name="T59" fmla="*/ 136 h 226"/>
                <a:gd name="T60" fmla="*/ 9 w 567"/>
                <a:gd name="T61" fmla="*/ 157 h 226"/>
                <a:gd name="T62" fmla="*/ 20 w 567"/>
                <a:gd name="T63" fmla="*/ 177 h 226"/>
                <a:gd name="T64" fmla="*/ 35 w 567"/>
                <a:gd name="T65" fmla="*/ 194 h 226"/>
                <a:gd name="T66" fmla="*/ 52 w 567"/>
                <a:gd name="T67" fmla="*/ 207 h 226"/>
                <a:gd name="T68" fmla="*/ 69 w 567"/>
                <a:gd name="T69" fmla="*/ 218 h 226"/>
                <a:gd name="T70" fmla="*/ 91 w 567"/>
                <a:gd name="T71" fmla="*/ 224 h 226"/>
                <a:gd name="T72" fmla="*/ 115 w 567"/>
                <a:gd name="T73" fmla="*/ 226 h 226"/>
                <a:gd name="T74" fmla="*/ 115 w 567"/>
                <a:gd name="T75" fmla="*/ 226 h 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567" h="226">
                  <a:moveTo>
                    <a:pt x="115" y="226"/>
                  </a:moveTo>
                  <a:lnTo>
                    <a:pt x="455" y="226"/>
                  </a:lnTo>
                  <a:lnTo>
                    <a:pt x="477" y="224"/>
                  </a:lnTo>
                  <a:lnTo>
                    <a:pt x="498" y="218"/>
                  </a:lnTo>
                  <a:lnTo>
                    <a:pt x="518" y="207"/>
                  </a:lnTo>
                  <a:lnTo>
                    <a:pt x="535" y="194"/>
                  </a:lnTo>
                  <a:lnTo>
                    <a:pt x="548" y="177"/>
                  </a:lnTo>
                  <a:lnTo>
                    <a:pt x="559" y="157"/>
                  </a:lnTo>
                  <a:lnTo>
                    <a:pt x="565" y="136"/>
                  </a:lnTo>
                  <a:lnTo>
                    <a:pt x="567" y="112"/>
                  </a:lnTo>
                  <a:lnTo>
                    <a:pt x="565" y="90"/>
                  </a:lnTo>
                  <a:lnTo>
                    <a:pt x="559" y="69"/>
                  </a:lnTo>
                  <a:lnTo>
                    <a:pt x="548" y="49"/>
                  </a:lnTo>
                  <a:lnTo>
                    <a:pt x="535" y="32"/>
                  </a:lnTo>
                  <a:lnTo>
                    <a:pt x="518" y="19"/>
                  </a:lnTo>
                  <a:lnTo>
                    <a:pt x="498" y="8"/>
                  </a:lnTo>
                  <a:lnTo>
                    <a:pt x="477" y="2"/>
                  </a:lnTo>
                  <a:lnTo>
                    <a:pt x="455" y="0"/>
                  </a:lnTo>
                  <a:lnTo>
                    <a:pt x="455" y="0"/>
                  </a:lnTo>
                  <a:lnTo>
                    <a:pt x="455" y="0"/>
                  </a:lnTo>
                  <a:lnTo>
                    <a:pt x="115" y="0"/>
                  </a:lnTo>
                  <a:lnTo>
                    <a:pt x="91" y="2"/>
                  </a:lnTo>
                  <a:lnTo>
                    <a:pt x="69" y="8"/>
                  </a:lnTo>
                  <a:lnTo>
                    <a:pt x="52" y="19"/>
                  </a:lnTo>
                  <a:lnTo>
                    <a:pt x="35" y="32"/>
                  </a:lnTo>
                  <a:lnTo>
                    <a:pt x="20" y="49"/>
                  </a:lnTo>
                  <a:lnTo>
                    <a:pt x="9" y="69"/>
                  </a:lnTo>
                  <a:lnTo>
                    <a:pt x="3" y="90"/>
                  </a:lnTo>
                  <a:lnTo>
                    <a:pt x="0" y="112"/>
                  </a:lnTo>
                  <a:lnTo>
                    <a:pt x="3" y="136"/>
                  </a:lnTo>
                  <a:lnTo>
                    <a:pt x="9" y="157"/>
                  </a:lnTo>
                  <a:lnTo>
                    <a:pt x="20" y="177"/>
                  </a:lnTo>
                  <a:lnTo>
                    <a:pt x="35" y="194"/>
                  </a:lnTo>
                  <a:lnTo>
                    <a:pt x="52" y="207"/>
                  </a:lnTo>
                  <a:lnTo>
                    <a:pt x="69" y="218"/>
                  </a:lnTo>
                  <a:lnTo>
                    <a:pt x="91" y="224"/>
                  </a:lnTo>
                  <a:lnTo>
                    <a:pt x="115" y="226"/>
                  </a:lnTo>
                  <a:lnTo>
                    <a:pt x="115" y="226"/>
                  </a:lnTo>
                  <a:close/>
                </a:path>
              </a:pathLst>
            </a:cu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" name="Freeform 6">
              <a:extLst>
                <a:ext uri="{FF2B5EF4-FFF2-40B4-BE49-F238E27FC236}">
                  <a16:creationId xmlns:a16="http://schemas.microsoft.com/office/drawing/2014/main" id="{613E6583-E5CE-9FDD-964B-220897FCA735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" y="11"/>
              <a:ext cx="567" cy="226"/>
            </a:xfrm>
            <a:custGeom>
              <a:avLst/>
              <a:gdLst>
                <a:gd name="T0" fmla="*/ 115 w 567"/>
                <a:gd name="T1" fmla="*/ 226 h 226"/>
                <a:gd name="T2" fmla="*/ 455 w 567"/>
                <a:gd name="T3" fmla="*/ 226 h 226"/>
                <a:gd name="T4" fmla="*/ 477 w 567"/>
                <a:gd name="T5" fmla="*/ 224 h 226"/>
                <a:gd name="T6" fmla="*/ 498 w 567"/>
                <a:gd name="T7" fmla="*/ 218 h 226"/>
                <a:gd name="T8" fmla="*/ 518 w 567"/>
                <a:gd name="T9" fmla="*/ 207 h 226"/>
                <a:gd name="T10" fmla="*/ 535 w 567"/>
                <a:gd name="T11" fmla="*/ 194 h 226"/>
                <a:gd name="T12" fmla="*/ 548 w 567"/>
                <a:gd name="T13" fmla="*/ 177 h 226"/>
                <a:gd name="T14" fmla="*/ 559 w 567"/>
                <a:gd name="T15" fmla="*/ 157 h 226"/>
                <a:gd name="T16" fmla="*/ 565 w 567"/>
                <a:gd name="T17" fmla="*/ 136 h 226"/>
                <a:gd name="T18" fmla="*/ 567 w 567"/>
                <a:gd name="T19" fmla="*/ 112 h 226"/>
                <a:gd name="T20" fmla="*/ 565 w 567"/>
                <a:gd name="T21" fmla="*/ 90 h 226"/>
                <a:gd name="T22" fmla="*/ 559 w 567"/>
                <a:gd name="T23" fmla="*/ 69 h 226"/>
                <a:gd name="T24" fmla="*/ 548 w 567"/>
                <a:gd name="T25" fmla="*/ 49 h 226"/>
                <a:gd name="T26" fmla="*/ 535 w 567"/>
                <a:gd name="T27" fmla="*/ 32 h 226"/>
                <a:gd name="T28" fmla="*/ 518 w 567"/>
                <a:gd name="T29" fmla="*/ 19 h 226"/>
                <a:gd name="T30" fmla="*/ 498 w 567"/>
                <a:gd name="T31" fmla="*/ 8 h 226"/>
                <a:gd name="T32" fmla="*/ 477 w 567"/>
                <a:gd name="T33" fmla="*/ 2 h 226"/>
                <a:gd name="T34" fmla="*/ 455 w 567"/>
                <a:gd name="T35" fmla="*/ 0 h 226"/>
                <a:gd name="T36" fmla="*/ 455 w 567"/>
                <a:gd name="T37" fmla="*/ 0 h 226"/>
                <a:gd name="T38" fmla="*/ 455 w 567"/>
                <a:gd name="T39" fmla="*/ 0 h 226"/>
                <a:gd name="T40" fmla="*/ 115 w 567"/>
                <a:gd name="T41" fmla="*/ 0 h 226"/>
                <a:gd name="T42" fmla="*/ 91 w 567"/>
                <a:gd name="T43" fmla="*/ 2 h 226"/>
                <a:gd name="T44" fmla="*/ 69 w 567"/>
                <a:gd name="T45" fmla="*/ 8 h 226"/>
                <a:gd name="T46" fmla="*/ 52 w 567"/>
                <a:gd name="T47" fmla="*/ 19 h 226"/>
                <a:gd name="T48" fmla="*/ 35 w 567"/>
                <a:gd name="T49" fmla="*/ 32 h 226"/>
                <a:gd name="T50" fmla="*/ 20 w 567"/>
                <a:gd name="T51" fmla="*/ 49 h 226"/>
                <a:gd name="T52" fmla="*/ 9 w 567"/>
                <a:gd name="T53" fmla="*/ 69 h 226"/>
                <a:gd name="T54" fmla="*/ 3 w 567"/>
                <a:gd name="T55" fmla="*/ 90 h 226"/>
                <a:gd name="T56" fmla="*/ 0 w 567"/>
                <a:gd name="T57" fmla="*/ 112 h 226"/>
                <a:gd name="T58" fmla="*/ 3 w 567"/>
                <a:gd name="T59" fmla="*/ 136 h 226"/>
                <a:gd name="T60" fmla="*/ 9 w 567"/>
                <a:gd name="T61" fmla="*/ 157 h 226"/>
                <a:gd name="T62" fmla="*/ 20 w 567"/>
                <a:gd name="T63" fmla="*/ 177 h 226"/>
                <a:gd name="T64" fmla="*/ 35 w 567"/>
                <a:gd name="T65" fmla="*/ 194 h 226"/>
                <a:gd name="T66" fmla="*/ 52 w 567"/>
                <a:gd name="T67" fmla="*/ 207 h 226"/>
                <a:gd name="T68" fmla="*/ 69 w 567"/>
                <a:gd name="T69" fmla="*/ 218 h 226"/>
                <a:gd name="T70" fmla="*/ 91 w 567"/>
                <a:gd name="T71" fmla="*/ 224 h 226"/>
                <a:gd name="T72" fmla="*/ 115 w 567"/>
                <a:gd name="T73" fmla="*/ 226 h 226"/>
                <a:gd name="T74" fmla="*/ 115 w 567"/>
                <a:gd name="T75" fmla="*/ 226 h 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567" h="226">
                  <a:moveTo>
                    <a:pt x="115" y="226"/>
                  </a:moveTo>
                  <a:lnTo>
                    <a:pt x="455" y="226"/>
                  </a:lnTo>
                  <a:lnTo>
                    <a:pt x="477" y="224"/>
                  </a:lnTo>
                  <a:lnTo>
                    <a:pt x="498" y="218"/>
                  </a:lnTo>
                  <a:lnTo>
                    <a:pt x="518" y="207"/>
                  </a:lnTo>
                  <a:lnTo>
                    <a:pt x="535" y="194"/>
                  </a:lnTo>
                  <a:lnTo>
                    <a:pt x="548" y="177"/>
                  </a:lnTo>
                  <a:lnTo>
                    <a:pt x="559" y="157"/>
                  </a:lnTo>
                  <a:lnTo>
                    <a:pt x="565" y="136"/>
                  </a:lnTo>
                  <a:lnTo>
                    <a:pt x="567" y="112"/>
                  </a:lnTo>
                  <a:lnTo>
                    <a:pt x="565" y="90"/>
                  </a:lnTo>
                  <a:lnTo>
                    <a:pt x="559" y="69"/>
                  </a:lnTo>
                  <a:lnTo>
                    <a:pt x="548" y="49"/>
                  </a:lnTo>
                  <a:lnTo>
                    <a:pt x="535" y="32"/>
                  </a:lnTo>
                  <a:lnTo>
                    <a:pt x="518" y="19"/>
                  </a:lnTo>
                  <a:lnTo>
                    <a:pt x="498" y="8"/>
                  </a:lnTo>
                  <a:lnTo>
                    <a:pt x="477" y="2"/>
                  </a:lnTo>
                  <a:lnTo>
                    <a:pt x="455" y="0"/>
                  </a:lnTo>
                  <a:lnTo>
                    <a:pt x="455" y="0"/>
                  </a:lnTo>
                  <a:lnTo>
                    <a:pt x="455" y="0"/>
                  </a:lnTo>
                  <a:lnTo>
                    <a:pt x="115" y="0"/>
                  </a:lnTo>
                  <a:lnTo>
                    <a:pt x="91" y="2"/>
                  </a:lnTo>
                  <a:lnTo>
                    <a:pt x="69" y="8"/>
                  </a:lnTo>
                  <a:lnTo>
                    <a:pt x="52" y="19"/>
                  </a:lnTo>
                  <a:lnTo>
                    <a:pt x="35" y="32"/>
                  </a:lnTo>
                  <a:lnTo>
                    <a:pt x="20" y="49"/>
                  </a:lnTo>
                  <a:lnTo>
                    <a:pt x="9" y="69"/>
                  </a:lnTo>
                  <a:lnTo>
                    <a:pt x="3" y="90"/>
                  </a:lnTo>
                  <a:lnTo>
                    <a:pt x="0" y="112"/>
                  </a:lnTo>
                  <a:lnTo>
                    <a:pt x="3" y="136"/>
                  </a:lnTo>
                  <a:lnTo>
                    <a:pt x="9" y="157"/>
                  </a:lnTo>
                  <a:lnTo>
                    <a:pt x="20" y="177"/>
                  </a:lnTo>
                  <a:lnTo>
                    <a:pt x="35" y="194"/>
                  </a:lnTo>
                  <a:lnTo>
                    <a:pt x="52" y="207"/>
                  </a:lnTo>
                  <a:lnTo>
                    <a:pt x="69" y="218"/>
                  </a:lnTo>
                  <a:lnTo>
                    <a:pt x="91" y="224"/>
                  </a:lnTo>
                  <a:lnTo>
                    <a:pt x="115" y="226"/>
                  </a:lnTo>
                  <a:lnTo>
                    <a:pt x="115" y="226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8F947D8D-68B5-025C-FF90-10E900DB5B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0" y="84"/>
              <a:ext cx="12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tart</a:t>
              </a:r>
              <a:endParaRPr 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C07C74F-EC03-F374-BB7B-373EDC41C9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" y="408"/>
              <a:ext cx="907" cy="226"/>
            </a:xfrm>
            <a:prstGeom prst="rect">
              <a:avLst/>
            </a:prstGeom>
            <a:solidFill>
              <a:srgbClr val="DBEE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82BE47F-B3BD-07F4-8727-AABE29A12C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" y="408"/>
              <a:ext cx="907" cy="226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ABED04D9-3EA8-C990-4D72-5B9413798F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" y="445"/>
              <a:ext cx="79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Different sensors are evaluated </a:t>
              </a:r>
              <a:endParaRPr 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96F1D8EA-5370-72C9-F2AF-B3F0D0A569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0" y="520"/>
              <a:ext cx="59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nd adjusted separately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2AEDD6E1-FFB5-646E-7B7D-17D3F3B427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" y="805"/>
              <a:ext cx="793" cy="229"/>
            </a:xfrm>
            <a:prstGeom prst="rect">
              <a:avLst/>
            </a:prstGeom>
            <a:solidFill>
              <a:srgbClr val="DBEE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C4BC9F8F-E77A-69EE-A705-15FECE32A3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" y="805"/>
              <a:ext cx="793" cy="229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09707AD9-9E98-38B1-E10A-0F5DF7D717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" y="842"/>
              <a:ext cx="53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Initialize the sending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57DEAE14-E51F-973D-68E3-3341A01BFE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" y="920"/>
              <a:ext cx="25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requency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1A004876-AABC-C5FD-C77D-F29174991A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6" y="805"/>
              <a:ext cx="793" cy="229"/>
            </a:xfrm>
            <a:prstGeom prst="rect">
              <a:avLst/>
            </a:prstGeom>
            <a:solidFill>
              <a:srgbClr val="DBEE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CBA5A8D3-6B54-DD1D-2444-789AAB7782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6" y="805"/>
              <a:ext cx="793" cy="229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E6BE43D6-3C1C-ADD8-7CE3-9D3AD80EDE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0" y="881"/>
              <a:ext cx="24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ampling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D3BD0126-F6A5-42CE-1CA8-25F8D89D7AC2}"/>
                </a:ext>
              </a:extLst>
            </p:cNvPr>
            <p:cNvSpPr>
              <a:spLocks/>
            </p:cNvSpPr>
            <p:nvPr/>
          </p:nvSpPr>
          <p:spPr bwMode="auto">
            <a:xfrm>
              <a:off x="575" y="1601"/>
              <a:ext cx="907" cy="341"/>
            </a:xfrm>
            <a:custGeom>
              <a:avLst/>
              <a:gdLst>
                <a:gd name="T0" fmla="*/ 0 w 907"/>
                <a:gd name="T1" fmla="*/ 171 h 341"/>
                <a:gd name="T2" fmla="*/ 455 w 907"/>
                <a:gd name="T3" fmla="*/ 0 h 341"/>
                <a:gd name="T4" fmla="*/ 907 w 907"/>
                <a:gd name="T5" fmla="*/ 171 h 341"/>
                <a:gd name="T6" fmla="*/ 455 w 907"/>
                <a:gd name="T7" fmla="*/ 341 h 341"/>
                <a:gd name="T8" fmla="*/ 0 w 907"/>
                <a:gd name="T9" fmla="*/ 17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07" h="341">
                  <a:moveTo>
                    <a:pt x="0" y="171"/>
                  </a:moveTo>
                  <a:lnTo>
                    <a:pt x="455" y="0"/>
                  </a:lnTo>
                  <a:lnTo>
                    <a:pt x="907" y="171"/>
                  </a:lnTo>
                  <a:lnTo>
                    <a:pt x="455" y="341"/>
                  </a:lnTo>
                  <a:lnTo>
                    <a:pt x="0" y="171"/>
                  </a:lnTo>
                  <a:close/>
                </a:path>
              </a:pathLst>
            </a:cu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C7973329-6EE1-C2BF-DC06-0E2C30E033C3}"/>
                </a:ext>
              </a:extLst>
            </p:cNvPr>
            <p:cNvSpPr>
              <a:spLocks/>
            </p:cNvSpPr>
            <p:nvPr/>
          </p:nvSpPr>
          <p:spPr bwMode="auto">
            <a:xfrm>
              <a:off x="575" y="1601"/>
              <a:ext cx="907" cy="341"/>
            </a:xfrm>
            <a:custGeom>
              <a:avLst/>
              <a:gdLst>
                <a:gd name="T0" fmla="*/ 0 w 907"/>
                <a:gd name="T1" fmla="*/ 171 h 341"/>
                <a:gd name="T2" fmla="*/ 455 w 907"/>
                <a:gd name="T3" fmla="*/ 0 h 341"/>
                <a:gd name="T4" fmla="*/ 907 w 907"/>
                <a:gd name="T5" fmla="*/ 171 h 341"/>
                <a:gd name="T6" fmla="*/ 455 w 907"/>
                <a:gd name="T7" fmla="*/ 341 h 341"/>
                <a:gd name="T8" fmla="*/ 0 w 907"/>
                <a:gd name="T9" fmla="*/ 17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07" h="341">
                  <a:moveTo>
                    <a:pt x="0" y="171"/>
                  </a:moveTo>
                  <a:lnTo>
                    <a:pt x="455" y="0"/>
                  </a:lnTo>
                  <a:lnTo>
                    <a:pt x="907" y="171"/>
                  </a:lnTo>
                  <a:lnTo>
                    <a:pt x="455" y="341"/>
                  </a:lnTo>
                  <a:lnTo>
                    <a:pt x="0" y="171"/>
                  </a:lnTo>
                  <a:close/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31ED5853-0E36-ED30-AD42-B2E779982A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9" y="1733"/>
              <a:ext cx="58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Evaluation of the node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913D918E-4C30-A0E6-5F3D-35A33D4E3B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" y="2057"/>
              <a:ext cx="907" cy="226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85C015E6-3005-7DF1-900E-14065D7D47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" y="2057"/>
              <a:ext cx="907" cy="226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E28C7D35-434C-123B-9698-2072E04BED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" y="2094"/>
              <a:ext cx="869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alculate the average value of the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928DEC99-D236-A1EB-86C1-18BD7AF9C9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6" y="2169"/>
              <a:ext cx="44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evaluation period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33E378B8-0F25-D837-8081-73D4DE9579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" y="2512"/>
              <a:ext cx="679" cy="227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E9D95647-0013-3EE8-7853-8055B4E2D3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" y="2512"/>
              <a:ext cx="679" cy="227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60D5ECFF-5028-E97D-7A57-3606D1FC61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" y="2547"/>
              <a:ext cx="39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alculate mean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1B85E243-594B-C5A3-C8DA-29652813D8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" y="2625"/>
              <a:ext cx="23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deviation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E9AE2EAC-A627-17B2-2A9F-A75A99A8BD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2" y="2512"/>
              <a:ext cx="681" cy="227"/>
            </a:xfrm>
            <a:prstGeom prst="rect">
              <a:avLst/>
            </a:prstGeom>
            <a:solidFill>
              <a:srgbClr val="D7E3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C8742DA1-9377-C7E1-9467-5379DCD53F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2" y="2512"/>
              <a:ext cx="681" cy="227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EA8C4E4B-78E0-6955-C527-D1C71F117D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5" y="2547"/>
              <a:ext cx="49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elect transmission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5437F2F0-0CAE-4200-B722-ED7B7E9377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5" y="2625"/>
              <a:ext cx="25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requency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531B6038-A588-BB3D-D793-9394AAB809FA}"/>
                </a:ext>
              </a:extLst>
            </p:cNvPr>
            <p:cNvSpPr>
              <a:spLocks/>
            </p:cNvSpPr>
            <p:nvPr/>
          </p:nvSpPr>
          <p:spPr bwMode="auto">
            <a:xfrm>
              <a:off x="530" y="2965"/>
              <a:ext cx="907" cy="341"/>
            </a:xfrm>
            <a:custGeom>
              <a:avLst/>
              <a:gdLst>
                <a:gd name="T0" fmla="*/ 0 w 907"/>
                <a:gd name="T1" fmla="*/ 171 h 341"/>
                <a:gd name="T2" fmla="*/ 453 w 907"/>
                <a:gd name="T3" fmla="*/ 0 h 341"/>
                <a:gd name="T4" fmla="*/ 907 w 907"/>
                <a:gd name="T5" fmla="*/ 171 h 341"/>
                <a:gd name="T6" fmla="*/ 453 w 907"/>
                <a:gd name="T7" fmla="*/ 341 h 341"/>
                <a:gd name="T8" fmla="*/ 0 w 907"/>
                <a:gd name="T9" fmla="*/ 17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07" h="341">
                  <a:moveTo>
                    <a:pt x="0" y="171"/>
                  </a:moveTo>
                  <a:lnTo>
                    <a:pt x="453" y="0"/>
                  </a:lnTo>
                  <a:lnTo>
                    <a:pt x="907" y="171"/>
                  </a:lnTo>
                  <a:lnTo>
                    <a:pt x="453" y="341"/>
                  </a:lnTo>
                  <a:lnTo>
                    <a:pt x="0" y="171"/>
                  </a:lnTo>
                  <a:close/>
                </a:path>
              </a:pathLst>
            </a:cu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262031C2-44D3-7B62-FF20-D5DC0BC9A01F}"/>
                </a:ext>
              </a:extLst>
            </p:cNvPr>
            <p:cNvSpPr>
              <a:spLocks/>
            </p:cNvSpPr>
            <p:nvPr/>
          </p:nvSpPr>
          <p:spPr bwMode="auto">
            <a:xfrm>
              <a:off x="530" y="2965"/>
              <a:ext cx="907" cy="341"/>
            </a:xfrm>
            <a:custGeom>
              <a:avLst/>
              <a:gdLst>
                <a:gd name="T0" fmla="*/ 0 w 907"/>
                <a:gd name="T1" fmla="*/ 171 h 341"/>
                <a:gd name="T2" fmla="*/ 453 w 907"/>
                <a:gd name="T3" fmla="*/ 0 h 341"/>
                <a:gd name="T4" fmla="*/ 907 w 907"/>
                <a:gd name="T5" fmla="*/ 171 h 341"/>
                <a:gd name="T6" fmla="*/ 453 w 907"/>
                <a:gd name="T7" fmla="*/ 341 h 341"/>
                <a:gd name="T8" fmla="*/ 0 w 907"/>
                <a:gd name="T9" fmla="*/ 17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07" h="341">
                  <a:moveTo>
                    <a:pt x="0" y="171"/>
                  </a:moveTo>
                  <a:lnTo>
                    <a:pt x="453" y="0"/>
                  </a:lnTo>
                  <a:lnTo>
                    <a:pt x="907" y="171"/>
                  </a:lnTo>
                  <a:lnTo>
                    <a:pt x="453" y="341"/>
                  </a:lnTo>
                  <a:lnTo>
                    <a:pt x="0" y="171"/>
                  </a:lnTo>
                  <a:close/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08B1CFDA-F03B-F7D9-A5CF-25B9E34EF2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" y="3058"/>
              <a:ext cx="57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Beyond the prescribed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D83D1C4D-478B-7D4C-9D39-A5653E9860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" y="3136"/>
              <a:ext cx="19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interval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45DD8FA1-6D6D-9CFF-225E-446933D820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" y="3421"/>
              <a:ext cx="907" cy="226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CDC003D8-9894-B46A-6CDB-539CA0BCC4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" y="3421"/>
              <a:ext cx="907" cy="226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B24C8800-8BD0-837C-8F32-66DD94F3FD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1" y="3458"/>
              <a:ext cx="605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djust the transmission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76BBB23D-48DF-35CC-EFB5-A1FDFC4E60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5" y="3533"/>
              <a:ext cx="25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requency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3EB47518-D69F-D149-E7D9-CCBCD5CA46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" y="1260"/>
              <a:ext cx="793" cy="227"/>
            </a:xfrm>
            <a:prstGeom prst="rect">
              <a:avLst/>
            </a:prstGeom>
            <a:solidFill>
              <a:srgbClr val="D7E3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FF98FB93-7787-071C-4228-3AB3D30BE0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" y="1260"/>
              <a:ext cx="793" cy="227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12871922-6B2B-414C-4779-B04EE0CE95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4" y="1297"/>
              <a:ext cx="49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end data based on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20C81A28-2261-1706-D919-721C794FEA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0" y="1373"/>
              <a:ext cx="28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arameters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cxnSp>
          <p:nvCxnSpPr>
            <p:cNvPr id="47" name="Line 46">
              <a:extLst>
                <a:ext uri="{FF2B5EF4-FFF2-40B4-BE49-F238E27FC236}">
                  <a16:creationId xmlns:a16="http://schemas.microsoft.com/office/drawing/2014/main" id="{5913F10C-0D43-1C3F-7F98-20DDC491B484}"/>
                </a:ext>
              </a:extLst>
            </p:cNvPr>
            <p:cNvCxnSpPr/>
            <p:nvPr/>
          </p:nvCxnSpPr>
          <p:spPr bwMode="auto">
            <a:xfrm>
              <a:off x="1030" y="237"/>
              <a:ext cx="0" cy="12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7F50D199-1AAE-A0B5-CD94-7FAF86088350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4" y="356"/>
              <a:ext cx="52" cy="52"/>
            </a:xfrm>
            <a:custGeom>
              <a:avLst/>
              <a:gdLst>
                <a:gd name="T0" fmla="*/ 52 w 52"/>
                <a:gd name="T1" fmla="*/ 0 h 52"/>
                <a:gd name="T2" fmla="*/ 26 w 52"/>
                <a:gd name="T3" fmla="*/ 52 h 52"/>
                <a:gd name="T4" fmla="*/ 0 w 52"/>
                <a:gd name="T5" fmla="*/ 0 h 52"/>
                <a:gd name="T6" fmla="*/ 52 w 52"/>
                <a:gd name="T7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2">
                  <a:moveTo>
                    <a:pt x="52" y="0"/>
                  </a:moveTo>
                  <a:lnTo>
                    <a:pt x="26" y="52"/>
                  </a:lnTo>
                  <a:lnTo>
                    <a:pt x="0" y="0"/>
                  </a:lnTo>
                  <a:lnTo>
                    <a:pt x="5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2F2B5457-B633-A0B3-C1D6-D9A11534A788}"/>
                </a:ext>
              </a:extLst>
            </p:cNvPr>
            <p:cNvSpPr>
              <a:spLocks/>
            </p:cNvSpPr>
            <p:nvPr/>
          </p:nvSpPr>
          <p:spPr bwMode="auto">
            <a:xfrm>
              <a:off x="407" y="634"/>
              <a:ext cx="623" cy="126"/>
            </a:xfrm>
            <a:custGeom>
              <a:avLst/>
              <a:gdLst>
                <a:gd name="T0" fmla="*/ 623 w 623"/>
                <a:gd name="T1" fmla="*/ 0 h 126"/>
                <a:gd name="T2" fmla="*/ 623 w 623"/>
                <a:gd name="T3" fmla="*/ 87 h 126"/>
                <a:gd name="T4" fmla="*/ 0 w 623"/>
                <a:gd name="T5" fmla="*/ 87 h 126"/>
                <a:gd name="T6" fmla="*/ 0 w 623"/>
                <a:gd name="T7" fmla="*/ 126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23" h="126">
                  <a:moveTo>
                    <a:pt x="623" y="0"/>
                  </a:moveTo>
                  <a:lnTo>
                    <a:pt x="623" y="87"/>
                  </a:lnTo>
                  <a:lnTo>
                    <a:pt x="0" y="87"/>
                  </a:lnTo>
                  <a:lnTo>
                    <a:pt x="0" y="12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21112530-AA62-9D37-5DB6-09B24AA562F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1" y="753"/>
              <a:ext cx="52" cy="52"/>
            </a:xfrm>
            <a:custGeom>
              <a:avLst/>
              <a:gdLst>
                <a:gd name="T0" fmla="*/ 52 w 52"/>
                <a:gd name="T1" fmla="*/ 0 h 52"/>
                <a:gd name="T2" fmla="*/ 26 w 52"/>
                <a:gd name="T3" fmla="*/ 52 h 52"/>
                <a:gd name="T4" fmla="*/ 0 w 52"/>
                <a:gd name="T5" fmla="*/ 0 h 52"/>
                <a:gd name="T6" fmla="*/ 52 w 52"/>
                <a:gd name="T7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2">
                  <a:moveTo>
                    <a:pt x="52" y="0"/>
                  </a:moveTo>
                  <a:lnTo>
                    <a:pt x="26" y="52"/>
                  </a:lnTo>
                  <a:lnTo>
                    <a:pt x="0" y="0"/>
                  </a:lnTo>
                  <a:lnTo>
                    <a:pt x="5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51" name="Line 50">
              <a:extLst>
                <a:ext uri="{FF2B5EF4-FFF2-40B4-BE49-F238E27FC236}">
                  <a16:creationId xmlns:a16="http://schemas.microsoft.com/office/drawing/2014/main" id="{2759F329-2ADF-FDA0-3804-96FC1B3DC46D}"/>
                </a:ext>
              </a:extLst>
            </p:cNvPr>
            <p:cNvCxnSpPr/>
            <p:nvPr/>
          </p:nvCxnSpPr>
          <p:spPr bwMode="auto">
            <a:xfrm>
              <a:off x="804" y="919"/>
              <a:ext cx="40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id="{B9197EE5-D3DD-003B-A15C-BAAC903E3BB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4" y="893"/>
              <a:ext cx="52" cy="52"/>
            </a:xfrm>
            <a:custGeom>
              <a:avLst/>
              <a:gdLst>
                <a:gd name="T0" fmla="*/ 0 w 52"/>
                <a:gd name="T1" fmla="*/ 0 h 52"/>
                <a:gd name="T2" fmla="*/ 52 w 52"/>
                <a:gd name="T3" fmla="*/ 26 h 52"/>
                <a:gd name="T4" fmla="*/ 0 w 52"/>
                <a:gd name="T5" fmla="*/ 52 h 52"/>
                <a:gd name="T6" fmla="*/ 0 w 52"/>
                <a:gd name="T7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2">
                  <a:moveTo>
                    <a:pt x="0" y="0"/>
                  </a:moveTo>
                  <a:lnTo>
                    <a:pt x="52" y="26"/>
                  </a:lnTo>
                  <a:lnTo>
                    <a:pt x="0" y="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" name="Freeform 52">
              <a:extLst>
                <a:ext uri="{FF2B5EF4-FFF2-40B4-BE49-F238E27FC236}">
                  <a16:creationId xmlns:a16="http://schemas.microsoft.com/office/drawing/2014/main" id="{6D94A8C2-E884-FE55-C865-E600EFFA241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0" y="1034"/>
              <a:ext cx="623" cy="181"/>
            </a:xfrm>
            <a:custGeom>
              <a:avLst/>
              <a:gdLst>
                <a:gd name="T0" fmla="*/ 623 w 623"/>
                <a:gd name="T1" fmla="*/ 0 h 181"/>
                <a:gd name="T2" fmla="*/ 623 w 623"/>
                <a:gd name="T3" fmla="*/ 84 h 181"/>
                <a:gd name="T4" fmla="*/ 0 w 623"/>
                <a:gd name="T5" fmla="*/ 84 h 181"/>
                <a:gd name="T6" fmla="*/ 0 w 623"/>
                <a:gd name="T7" fmla="*/ 181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23" h="181">
                  <a:moveTo>
                    <a:pt x="623" y="0"/>
                  </a:moveTo>
                  <a:lnTo>
                    <a:pt x="623" y="84"/>
                  </a:lnTo>
                  <a:lnTo>
                    <a:pt x="0" y="84"/>
                  </a:lnTo>
                  <a:lnTo>
                    <a:pt x="0" y="181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id="{79D4FE91-F24B-DEFA-3E83-476BB0CE2668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4" y="1209"/>
              <a:ext cx="52" cy="51"/>
            </a:xfrm>
            <a:custGeom>
              <a:avLst/>
              <a:gdLst>
                <a:gd name="T0" fmla="*/ 52 w 52"/>
                <a:gd name="T1" fmla="*/ 0 h 51"/>
                <a:gd name="T2" fmla="*/ 26 w 52"/>
                <a:gd name="T3" fmla="*/ 51 h 51"/>
                <a:gd name="T4" fmla="*/ 0 w 52"/>
                <a:gd name="T5" fmla="*/ 0 h 51"/>
                <a:gd name="T6" fmla="*/ 52 w 52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1">
                  <a:moveTo>
                    <a:pt x="52" y="0"/>
                  </a:moveTo>
                  <a:lnTo>
                    <a:pt x="26" y="51"/>
                  </a:lnTo>
                  <a:lnTo>
                    <a:pt x="0" y="0"/>
                  </a:lnTo>
                  <a:lnTo>
                    <a:pt x="5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55" name="Line 54">
              <a:extLst>
                <a:ext uri="{FF2B5EF4-FFF2-40B4-BE49-F238E27FC236}">
                  <a16:creationId xmlns:a16="http://schemas.microsoft.com/office/drawing/2014/main" id="{FD193809-A8BD-7C06-5B14-48D888D18550}"/>
                </a:ext>
              </a:extLst>
            </p:cNvPr>
            <p:cNvCxnSpPr/>
            <p:nvPr/>
          </p:nvCxnSpPr>
          <p:spPr bwMode="auto">
            <a:xfrm>
              <a:off x="1030" y="1487"/>
              <a:ext cx="0" cy="6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id="{9FADA327-1B97-138C-AEF3-A1A7754313C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4" y="1550"/>
              <a:ext cx="52" cy="51"/>
            </a:xfrm>
            <a:custGeom>
              <a:avLst/>
              <a:gdLst>
                <a:gd name="T0" fmla="*/ 52 w 52"/>
                <a:gd name="T1" fmla="*/ 0 h 51"/>
                <a:gd name="T2" fmla="*/ 26 w 52"/>
                <a:gd name="T3" fmla="*/ 51 h 51"/>
                <a:gd name="T4" fmla="*/ 0 w 52"/>
                <a:gd name="T5" fmla="*/ 0 h 51"/>
                <a:gd name="T6" fmla="*/ 52 w 52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1">
                  <a:moveTo>
                    <a:pt x="52" y="0"/>
                  </a:moveTo>
                  <a:lnTo>
                    <a:pt x="26" y="51"/>
                  </a:lnTo>
                  <a:lnTo>
                    <a:pt x="0" y="0"/>
                  </a:lnTo>
                  <a:lnTo>
                    <a:pt x="5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" name="Freeform 56">
              <a:extLst>
                <a:ext uri="{FF2B5EF4-FFF2-40B4-BE49-F238E27FC236}">
                  <a16:creationId xmlns:a16="http://schemas.microsoft.com/office/drawing/2014/main" id="{33E78BC9-CCFB-9953-E21A-990AB0FD46D1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2" y="919"/>
              <a:ext cx="651" cy="853"/>
            </a:xfrm>
            <a:custGeom>
              <a:avLst/>
              <a:gdLst>
                <a:gd name="T0" fmla="*/ 0 w 651"/>
                <a:gd name="T1" fmla="*/ 853 h 853"/>
                <a:gd name="T2" fmla="*/ 651 w 651"/>
                <a:gd name="T3" fmla="*/ 853 h 853"/>
                <a:gd name="T4" fmla="*/ 651 w 651"/>
                <a:gd name="T5" fmla="*/ 0 h 853"/>
                <a:gd name="T6" fmla="*/ 612 w 651"/>
                <a:gd name="T7" fmla="*/ 0 h 8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1" h="853">
                  <a:moveTo>
                    <a:pt x="0" y="853"/>
                  </a:moveTo>
                  <a:lnTo>
                    <a:pt x="651" y="853"/>
                  </a:lnTo>
                  <a:lnTo>
                    <a:pt x="651" y="0"/>
                  </a:lnTo>
                  <a:lnTo>
                    <a:pt x="612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id="{4B63BA4E-7BF6-90BE-11AD-4D6FF95F1631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9" y="893"/>
              <a:ext cx="52" cy="52"/>
            </a:xfrm>
            <a:custGeom>
              <a:avLst/>
              <a:gdLst>
                <a:gd name="T0" fmla="*/ 52 w 52"/>
                <a:gd name="T1" fmla="*/ 52 h 52"/>
                <a:gd name="T2" fmla="*/ 0 w 52"/>
                <a:gd name="T3" fmla="*/ 26 h 52"/>
                <a:gd name="T4" fmla="*/ 52 w 52"/>
                <a:gd name="T5" fmla="*/ 0 h 52"/>
                <a:gd name="T6" fmla="*/ 52 w 52"/>
                <a:gd name="T7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2">
                  <a:moveTo>
                    <a:pt x="52" y="52"/>
                  </a:moveTo>
                  <a:lnTo>
                    <a:pt x="0" y="26"/>
                  </a:lnTo>
                  <a:lnTo>
                    <a:pt x="52" y="0"/>
                  </a:lnTo>
                  <a:lnTo>
                    <a:pt x="52" y="5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59" name="Line 58">
              <a:extLst>
                <a:ext uri="{FF2B5EF4-FFF2-40B4-BE49-F238E27FC236}">
                  <a16:creationId xmlns:a16="http://schemas.microsoft.com/office/drawing/2014/main" id="{105F50FF-3A77-FB3B-4A3B-578B897C6EDD}"/>
                </a:ext>
              </a:extLst>
            </p:cNvPr>
            <p:cNvCxnSpPr/>
            <p:nvPr/>
          </p:nvCxnSpPr>
          <p:spPr bwMode="auto">
            <a:xfrm>
              <a:off x="1030" y="1942"/>
              <a:ext cx="0" cy="6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id="{F7F62694-0A22-94D3-9999-CA852FF4EC38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4" y="2005"/>
              <a:ext cx="52" cy="52"/>
            </a:xfrm>
            <a:custGeom>
              <a:avLst/>
              <a:gdLst>
                <a:gd name="T0" fmla="*/ 52 w 52"/>
                <a:gd name="T1" fmla="*/ 0 h 52"/>
                <a:gd name="T2" fmla="*/ 26 w 52"/>
                <a:gd name="T3" fmla="*/ 52 h 52"/>
                <a:gd name="T4" fmla="*/ 0 w 52"/>
                <a:gd name="T5" fmla="*/ 0 h 52"/>
                <a:gd name="T6" fmla="*/ 52 w 52"/>
                <a:gd name="T7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2">
                  <a:moveTo>
                    <a:pt x="52" y="0"/>
                  </a:moveTo>
                  <a:lnTo>
                    <a:pt x="26" y="52"/>
                  </a:lnTo>
                  <a:lnTo>
                    <a:pt x="0" y="0"/>
                  </a:lnTo>
                  <a:lnTo>
                    <a:pt x="5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id="{3CC46549-FBAB-DC5C-21D1-D30D3BC5A06C}"/>
                </a:ext>
              </a:extLst>
            </p:cNvPr>
            <p:cNvSpPr>
              <a:spLocks/>
            </p:cNvSpPr>
            <p:nvPr/>
          </p:nvSpPr>
          <p:spPr bwMode="auto">
            <a:xfrm>
              <a:off x="519" y="2283"/>
              <a:ext cx="511" cy="182"/>
            </a:xfrm>
            <a:custGeom>
              <a:avLst/>
              <a:gdLst>
                <a:gd name="T0" fmla="*/ 511 w 511"/>
                <a:gd name="T1" fmla="*/ 0 h 182"/>
                <a:gd name="T2" fmla="*/ 511 w 511"/>
                <a:gd name="T3" fmla="*/ 87 h 182"/>
                <a:gd name="T4" fmla="*/ 0 w 511"/>
                <a:gd name="T5" fmla="*/ 87 h 182"/>
                <a:gd name="T6" fmla="*/ 0 w 511"/>
                <a:gd name="T7" fmla="*/ 182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1" h="182">
                  <a:moveTo>
                    <a:pt x="511" y="0"/>
                  </a:moveTo>
                  <a:lnTo>
                    <a:pt x="511" y="87"/>
                  </a:lnTo>
                  <a:lnTo>
                    <a:pt x="0" y="87"/>
                  </a:lnTo>
                  <a:lnTo>
                    <a:pt x="0" y="182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Freeform 61">
              <a:extLst>
                <a:ext uri="{FF2B5EF4-FFF2-40B4-BE49-F238E27FC236}">
                  <a16:creationId xmlns:a16="http://schemas.microsoft.com/office/drawing/2014/main" id="{8DD62C21-D50F-8D2F-5EA2-3601F4995710}"/>
                </a:ext>
              </a:extLst>
            </p:cNvPr>
            <p:cNvSpPr>
              <a:spLocks/>
            </p:cNvSpPr>
            <p:nvPr/>
          </p:nvSpPr>
          <p:spPr bwMode="auto">
            <a:xfrm>
              <a:off x="493" y="2458"/>
              <a:ext cx="52" cy="54"/>
            </a:xfrm>
            <a:custGeom>
              <a:avLst/>
              <a:gdLst>
                <a:gd name="T0" fmla="*/ 52 w 52"/>
                <a:gd name="T1" fmla="*/ 0 h 54"/>
                <a:gd name="T2" fmla="*/ 26 w 52"/>
                <a:gd name="T3" fmla="*/ 54 h 54"/>
                <a:gd name="T4" fmla="*/ 0 w 52"/>
                <a:gd name="T5" fmla="*/ 0 h 54"/>
                <a:gd name="T6" fmla="*/ 52 w 52"/>
                <a:gd name="T7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4">
                  <a:moveTo>
                    <a:pt x="52" y="0"/>
                  </a:moveTo>
                  <a:lnTo>
                    <a:pt x="26" y="54"/>
                  </a:lnTo>
                  <a:lnTo>
                    <a:pt x="0" y="0"/>
                  </a:lnTo>
                  <a:lnTo>
                    <a:pt x="5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63" name="Line 62">
              <a:extLst>
                <a:ext uri="{FF2B5EF4-FFF2-40B4-BE49-F238E27FC236}">
                  <a16:creationId xmlns:a16="http://schemas.microsoft.com/office/drawing/2014/main" id="{669D892E-DF38-45EE-53F2-246726A2B3D2}"/>
                </a:ext>
              </a:extLst>
            </p:cNvPr>
            <p:cNvCxnSpPr/>
            <p:nvPr/>
          </p:nvCxnSpPr>
          <p:spPr bwMode="auto">
            <a:xfrm>
              <a:off x="860" y="2624"/>
              <a:ext cx="23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6B60D61B-5EC1-72C3-3569-42928EE610C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90" y="2598"/>
              <a:ext cx="52" cy="52"/>
            </a:xfrm>
            <a:custGeom>
              <a:avLst/>
              <a:gdLst>
                <a:gd name="T0" fmla="*/ 0 w 52"/>
                <a:gd name="T1" fmla="*/ 0 h 52"/>
                <a:gd name="T2" fmla="*/ 52 w 52"/>
                <a:gd name="T3" fmla="*/ 26 h 52"/>
                <a:gd name="T4" fmla="*/ 0 w 52"/>
                <a:gd name="T5" fmla="*/ 52 h 52"/>
                <a:gd name="T6" fmla="*/ 0 w 52"/>
                <a:gd name="T7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2">
                  <a:moveTo>
                    <a:pt x="0" y="0"/>
                  </a:moveTo>
                  <a:lnTo>
                    <a:pt x="52" y="26"/>
                  </a:lnTo>
                  <a:lnTo>
                    <a:pt x="0" y="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Freeform 64">
              <a:extLst>
                <a:ext uri="{FF2B5EF4-FFF2-40B4-BE49-F238E27FC236}">
                  <a16:creationId xmlns:a16="http://schemas.microsoft.com/office/drawing/2014/main" id="{4672B358-BDB9-E5B6-1F33-6079E2A30344}"/>
                </a:ext>
              </a:extLst>
            </p:cNvPr>
            <p:cNvSpPr>
              <a:spLocks/>
            </p:cNvSpPr>
            <p:nvPr/>
          </p:nvSpPr>
          <p:spPr bwMode="auto">
            <a:xfrm>
              <a:off x="983" y="2739"/>
              <a:ext cx="499" cy="181"/>
            </a:xfrm>
            <a:custGeom>
              <a:avLst/>
              <a:gdLst>
                <a:gd name="T0" fmla="*/ 499 w 499"/>
                <a:gd name="T1" fmla="*/ 0 h 181"/>
                <a:gd name="T2" fmla="*/ 499 w 499"/>
                <a:gd name="T3" fmla="*/ 84 h 181"/>
                <a:gd name="T4" fmla="*/ 0 w 499"/>
                <a:gd name="T5" fmla="*/ 84 h 181"/>
                <a:gd name="T6" fmla="*/ 0 w 499"/>
                <a:gd name="T7" fmla="*/ 181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99" h="181">
                  <a:moveTo>
                    <a:pt x="499" y="0"/>
                  </a:moveTo>
                  <a:lnTo>
                    <a:pt x="499" y="84"/>
                  </a:lnTo>
                  <a:lnTo>
                    <a:pt x="0" y="84"/>
                  </a:lnTo>
                  <a:lnTo>
                    <a:pt x="0" y="181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id="{4F14358B-4CE3-4734-FA90-85682D15EDFC}"/>
                </a:ext>
              </a:extLst>
            </p:cNvPr>
            <p:cNvSpPr>
              <a:spLocks/>
            </p:cNvSpPr>
            <p:nvPr/>
          </p:nvSpPr>
          <p:spPr bwMode="auto">
            <a:xfrm>
              <a:off x="957" y="2913"/>
              <a:ext cx="51" cy="52"/>
            </a:xfrm>
            <a:custGeom>
              <a:avLst/>
              <a:gdLst>
                <a:gd name="T0" fmla="*/ 51 w 51"/>
                <a:gd name="T1" fmla="*/ 0 h 52"/>
                <a:gd name="T2" fmla="*/ 26 w 51"/>
                <a:gd name="T3" fmla="*/ 52 h 52"/>
                <a:gd name="T4" fmla="*/ 0 w 51"/>
                <a:gd name="T5" fmla="*/ 0 h 52"/>
                <a:gd name="T6" fmla="*/ 51 w 51"/>
                <a:gd name="T7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2">
                  <a:moveTo>
                    <a:pt x="51" y="0"/>
                  </a:moveTo>
                  <a:lnTo>
                    <a:pt x="26" y="52"/>
                  </a:lnTo>
                  <a:lnTo>
                    <a:pt x="0" y="0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cxnSp>
          <p:nvCxnSpPr>
            <p:cNvPr id="67" name="Line 66">
              <a:extLst>
                <a:ext uri="{FF2B5EF4-FFF2-40B4-BE49-F238E27FC236}">
                  <a16:creationId xmlns:a16="http://schemas.microsoft.com/office/drawing/2014/main" id="{97D50F68-05CC-AE57-8EC9-FF3027C580BA}"/>
                </a:ext>
              </a:extLst>
            </p:cNvPr>
            <p:cNvCxnSpPr/>
            <p:nvPr/>
          </p:nvCxnSpPr>
          <p:spPr bwMode="auto">
            <a:xfrm>
              <a:off x="983" y="3306"/>
              <a:ext cx="0" cy="6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8" name="Freeform 67">
              <a:extLst>
                <a:ext uri="{FF2B5EF4-FFF2-40B4-BE49-F238E27FC236}">
                  <a16:creationId xmlns:a16="http://schemas.microsoft.com/office/drawing/2014/main" id="{CA0001BF-C558-1516-B556-65308EA2EFF5}"/>
                </a:ext>
              </a:extLst>
            </p:cNvPr>
            <p:cNvSpPr>
              <a:spLocks/>
            </p:cNvSpPr>
            <p:nvPr/>
          </p:nvSpPr>
          <p:spPr bwMode="auto">
            <a:xfrm>
              <a:off x="957" y="3369"/>
              <a:ext cx="51" cy="52"/>
            </a:xfrm>
            <a:custGeom>
              <a:avLst/>
              <a:gdLst>
                <a:gd name="T0" fmla="*/ 51 w 51"/>
                <a:gd name="T1" fmla="*/ 0 h 52"/>
                <a:gd name="T2" fmla="*/ 26 w 51"/>
                <a:gd name="T3" fmla="*/ 52 h 52"/>
                <a:gd name="T4" fmla="*/ 0 w 51"/>
                <a:gd name="T5" fmla="*/ 0 h 52"/>
                <a:gd name="T6" fmla="*/ 51 w 51"/>
                <a:gd name="T7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2">
                  <a:moveTo>
                    <a:pt x="51" y="0"/>
                  </a:moveTo>
                  <a:lnTo>
                    <a:pt x="26" y="52"/>
                  </a:lnTo>
                  <a:lnTo>
                    <a:pt x="0" y="0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" name="Freeform 68">
              <a:extLst>
                <a:ext uri="{FF2B5EF4-FFF2-40B4-BE49-F238E27FC236}">
                  <a16:creationId xmlns:a16="http://schemas.microsoft.com/office/drawing/2014/main" id="{56CFF09A-5131-A718-9687-B84ABF0A309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7" y="919"/>
              <a:ext cx="696" cy="2217"/>
            </a:xfrm>
            <a:custGeom>
              <a:avLst/>
              <a:gdLst>
                <a:gd name="T0" fmla="*/ 0 w 696"/>
                <a:gd name="T1" fmla="*/ 2217 h 2217"/>
                <a:gd name="T2" fmla="*/ 696 w 696"/>
                <a:gd name="T3" fmla="*/ 2217 h 2217"/>
                <a:gd name="T4" fmla="*/ 696 w 696"/>
                <a:gd name="T5" fmla="*/ 0 h 2217"/>
                <a:gd name="T6" fmla="*/ 657 w 696"/>
                <a:gd name="T7" fmla="*/ 0 h 22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96" h="2217">
                  <a:moveTo>
                    <a:pt x="0" y="2217"/>
                  </a:moveTo>
                  <a:lnTo>
                    <a:pt x="696" y="2217"/>
                  </a:lnTo>
                  <a:lnTo>
                    <a:pt x="696" y="0"/>
                  </a:lnTo>
                  <a:lnTo>
                    <a:pt x="657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" name="Freeform 69">
              <a:extLst>
                <a:ext uri="{FF2B5EF4-FFF2-40B4-BE49-F238E27FC236}">
                  <a16:creationId xmlns:a16="http://schemas.microsoft.com/office/drawing/2014/main" id="{60198968-D3C8-97A9-6264-3E1ED03F5C4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9" y="893"/>
              <a:ext cx="52" cy="52"/>
            </a:xfrm>
            <a:custGeom>
              <a:avLst/>
              <a:gdLst>
                <a:gd name="T0" fmla="*/ 52 w 52"/>
                <a:gd name="T1" fmla="*/ 52 h 52"/>
                <a:gd name="T2" fmla="*/ 0 w 52"/>
                <a:gd name="T3" fmla="*/ 26 h 52"/>
                <a:gd name="T4" fmla="*/ 52 w 52"/>
                <a:gd name="T5" fmla="*/ 0 h 52"/>
                <a:gd name="T6" fmla="*/ 52 w 52"/>
                <a:gd name="T7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2">
                  <a:moveTo>
                    <a:pt x="52" y="52"/>
                  </a:moveTo>
                  <a:lnTo>
                    <a:pt x="0" y="26"/>
                  </a:lnTo>
                  <a:lnTo>
                    <a:pt x="52" y="0"/>
                  </a:lnTo>
                  <a:lnTo>
                    <a:pt x="52" y="5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Freeform 70">
              <a:extLst>
                <a:ext uri="{FF2B5EF4-FFF2-40B4-BE49-F238E27FC236}">
                  <a16:creationId xmlns:a16="http://schemas.microsoft.com/office/drawing/2014/main" id="{D8DD90B8-D4E7-C68B-B579-CACDE07DCFA7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7" y="919"/>
              <a:ext cx="696" cy="2616"/>
            </a:xfrm>
            <a:custGeom>
              <a:avLst/>
              <a:gdLst>
                <a:gd name="T0" fmla="*/ 0 w 696"/>
                <a:gd name="T1" fmla="*/ 2616 h 2616"/>
                <a:gd name="T2" fmla="*/ 696 w 696"/>
                <a:gd name="T3" fmla="*/ 2616 h 2616"/>
                <a:gd name="T4" fmla="*/ 696 w 696"/>
                <a:gd name="T5" fmla="*/ 0 h 2616"/>
                <a:gd name="T6" fmla="*/ 657 w 696"/>
                <a:gd name="T7" fmla="*/ 0 h 26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96" h="2616">
                  <a:moveTo>
                    <a:pt x="0" y="2616"/>
                  </a:moveTo>
                  <a:lnTo>
                    <a:pt x="696" y="2616"/>
                  </a:lnTo>
                  <a:lnTo>
                    <a:pt x="696" y="0"/>
                  </a:lnTo>
                  <a:lnTo>
                    <a:pt x="657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" name="Freeform 71">
              <a:extLst>
                <a:ext uri="{FF2B5EF4-FFF2-40B4-BE49-F238E27FC236}">
                  <a16:creationId xmlns:a16="http://schemas.microsoft.com/office/drawing/2014/main" id="{BD6FE2C5-12BB-A47C-8A94-DC54B755E8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9" y="893"/>
              <a:ext cx="52" cy="52"/>
            </a:xfrm>
            <a:custGeom>
              <a:avLst/>
              <a:gdLst>
                <a:gd name="T0" fmla="*/ 52 w 52"/>
                <a:gd name="T1" fmla="*/ 52 h 52"/>
                <a:gd name="T2" fmla="*/ 0 w 52"/>
                <a:gd name="T3" fmla="*/ 26 h 52"/>
                <a:gd name="T4" fmla="*/ 52 w 52"/>
                <a:gd name="T5" fmla="*/ 0 h 52"/>
                <a:gd name="T6" fmla="*/ 52 w 52"/>
                <a:gd name="T7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2">
                  <a:moveTo>
                    <a:pt x="52" y="52"/>
                  </a:moveTo>
                  <a:lnTo>
                    <a:pt x="0" y="26"/>
                  </a:lnTo>
                  <a:lnTo>
                    <a:pt x="52" y="0"/>
                  </a:lnTo>
                  <a:lnTo>
                    <a:pt x="52" y="5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D8C4C97F-99B9-EE17-C4E2-F28771BCDA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2" y="3302"/>
              <a:ext cx="10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503C1268-8CA3-EECE-13D5-6FD738E367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0" y="2961"/>
              <a:ext cx="7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F9279A32-65E8-46D7-A2ED-68D263780A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5" y="1938"/>
              <a:ext cx="10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Yes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DA098033-23ED-20EE-EC8C-1A92678A31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8" y="1528"/>
              <a:ext cx="7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No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84670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</Words>
  <Application>Microsoft Office PowerPoint</Application>
  <PresentationFormat>宽屏</PresentationFormat>
  <Paragraphs>2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</cp:revision>
  <dcterms:created xsi:type="dcterms:W3CDTF">2022-12-02T05:31:28Z</dcterms:created>
  <dcterms:modified xsi:type="dcterms:W3CDTF">2022-12-02T05:31:44Z</dcterms:modified>
</cp:coreProperties>
</file>